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C7CF8-54CB-473A-8870-D01EEAB67D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116CD-DC1A-4623-B592-5E1639D24D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E3FAF-2D68-47C5-A9AE-D7B924B8BA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24F60-DCF3-4698-B39C-7EE6343B8D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D87F2-77A6-4139-8E92-B94D173601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C5A20-06C1-4790-8394-92968D4E04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DE868-67D6-424D-ACF8-3ECE45D852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E8658-8E6D-478E-9907-6FB2BA8D66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8E60E-C26C-47CB-B72B-0D4BD1A225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6A223-85ED-4AD4-992B-EE79CD950B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2C924-BAA9-44C9-959F-0BC9A1DDCD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43473-8721-43A1-8914-9A8C13F4AB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967585-0984-4754-9458-A079B415199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71680" y="2340000"/>
          <a:ext cx="5905440" cy="1690560"/>
        </p:xfrm>
        <a:graphic>
          <a:graphicData uri="http://schemas.openxmlformats.org/drawingml/2006/table">
            <a:tbl>
              <a:tblPr/>
              <a:tblGrid>
                <a:gridCol w="5905440"/>
              </a:tblGrid>
              <a:tr h="3189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   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Samples                  Average C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T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 of 16s rDNA primer         Average C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T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 of GAPD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7160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Uninfected (n=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p38α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fl/fl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                       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Undetermined                                   24.21 ± 0.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Villin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Cre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-p38α</a:t>
                      </a:r>
                      <a:r>
                        <a:rPr b="0" lang="el-GR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∆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IEC 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           Undetermined                                   22.40 ± 1.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itrobacter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infected (n=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p38α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fl/fl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                              13.63 ± 0.86                                 22.40 ± 1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Villin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Cre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-p38α</a:t>
                      </a:r>
                      <a:r>
                        <a:rPr b="0" lang="el-GR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ＭＳ Ｐゴシック"/>
                        </a:rPr>
                        <a:t>∆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平成明朝"/>
                        </a:rPr>
                        <a:t>IEC 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    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   24.41 ± 3.14                                 21.41 ± 0.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 Box 45"/>
          <p:cNvSpPr/>
          <p:nvPr/>
        </p:nvSpPr>
        <p:spPr>
          <a:xfrm>
            <a:off x="788760" y="1208160"/>
            <a:ext cx="3705840" cy="82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ry Tab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Quantitation of Citrobacter rodentium infection by qPC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6T06:45:24Z</dcterms:created>
  <dc:creator>HanLab</dc:creator>
  <dc:description/>
  <dc:language>en-US</dc:language>
  <cp:lastModifiedBy>HanLab</cp:lastModifiedBy>
  <dcterms:modified xsi:type="dcterms:W3CDTF">2010-04-26T07:39:36Z</dcterms:modified>
  <cp:revision>3</cp:revision>
  <dc:subject/>
  <dc:title>幻灯片 1</dc:title>
</cp:coreProperties>
</file>